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1" r:id="rId2"/>
    <p:sldId id="262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206"/>
    <p:restoredTop sz="94656"/>
  </p:normalViewPr>
  <p:slideViewPr>
    <p:cSldViewPr snapToGrid="0">
      <p:cViewPr>
        <p:scale>
          <a:sx n="70" d="100"/>
          <a:sy n="70" d="100"/>
        </p:scale>
        <p:origin x="1248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35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751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36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450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795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453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73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931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882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594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754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8C718A-AA21-E346-9F1A-FA53956CB76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559FDB-2872-7645-8A71-AFD352DB9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585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6DFC9DD-E17F-6D16-056D-F8B4DA44DA9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49686"/>
          <a:stretch/>
        </p:blipFill>
        <p:spPr>
          <a:xfrm>
            <a:off x="585534" y="2811859"/>
            <a:ext cx="5991727" cy="2804497"/>
          </a:xfrm>
          <a:prstGeom prst="rect">
            <a:avLst/>
          </a:prstGeom>
        </p:spPr>
      </p:pic>
      <p:pic>
        <p:nvPicPr>
          <p:cNvPr id="7" name="Picture 6" descr="A screenshot of a graph&#10;&#10;AI-generated content may be incorrect.">
            <a:extLst>
              <a:ext uri="{FF2B5EF4-FFF2-40B4-BE49-F238E27FC236}">
                <a16:creationId xmlns:a16="http://schemas.microsoft.com/office/drawing/2014/main" id="{FD1EBF59-E788-FB5B-3CA1-E57C67B74BB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5787" b="50640"/>
          <a:stretch/>
        </p:blipFill>
        <p:spPr>
          <a:xfrm>
            <a:off x="585536" y="585215"/>
            <a:ext cx="6053852" cy="26700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11F3F3D-CC9E-F41A-9025-0F1F6EAD88F5}"/>
              </a:ext>
            </a:extLst>
          </p:cNvPr>
          <p:cNvSpPr txBox="1"/>
          <p:nvPr/>
        </p:nvSpPr>
        <p:spPr>
          <a:xfrm>
            <a:off x="353152" y="2350065"/>
            <a:ext cx="6456493" cy="75912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04A7E0-0ECE-88D7-64C3-426876A6F19F}"/>
              </a:ext>
            </a:extLst>
          </p:cNvPr>
          <p:cNvSpPr txBox="1"/>
          <p:nvPr/>
        </p:nvSpPr>
        <p:spPr>
          <a:xfrm rot="10800000">
            <a:off x="862228" y="5155483"/>
            <a:ext cx="4607954" cy="75912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3EFFD40-E86D-A23C-1D10-7A0CEE19D5E8}"/>
              </a:ext>
            </a:extLst>
          </p:cNvPr>
          <p:cNvSpPr txBox="1"/>
          <p:nvPr/>
        </p:nvSpPr>
        <p:spPr>
          <a:xfrm>
            <a:off x="353152" y="6980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47D4D6-4687-45D6-536D-042B68B0B8A1}"/>
              </a:ext>
            </a:extLst>
          </p:cNvPr>
          <p:cNvSpPr txBox="1"/>
          <p:nvPr/>
        </p:nvSpPr>
        <p:spPr>
          <a:xfrm>
            <a:off x="530670" y="512063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D87C3E-8C24-ACC6-748D-73B796688731}"/>
              </a:ext>
            </a:extLst>
          </p:cNvPr>
          <p:cNvSpPr txBox="1"/>
          <p:nvPr/>
        </p:nvSpPr>
        <p:spPr>
          <a:xfrm>
            <a:off x="555054" y="280415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D68EE1-801B-FD43-AD2C-9874A3253233}"/>
              </a:ext>
            </a:extLst>
          </p:cNvPr>
          <p:cNvSpPr txBox="1"/>
          <p:nvPr/>
        </p:nvSpPr>
        <p:spPr>
          <a:xfrm>
            <a:off x="693874" y="5801151"/>
            <a:ext cx="575882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Single-cell RNA sequencing of children with PANS 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ersus controls 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 of features, counts and mitochondrial percentage across samples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portion of individual cell types across samples  </a:t>
            </a:r>
          </a:p>
        </p:txBody>
      </p:sp>
    </p:spTree>
    <p:extLst>
      <p:ext uri="{BB962C8B-B14F-4D97-AF65-F5344CB8AC3E}">
        <p14:creationId xmlns:p14="http://schemas.microsoft.com/office/powerpoint/2010/main" val="790964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C44FAD3-2BC9-5286-7597-263A8EACA6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643" y="127351"/>
            <a:ext cx="6506713" cy="976007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BD3480E-1665-AF5C-AD25-707D5A9C6F56}"/>
              </a:ext>
            </a:extLst>
          </p:cNvPr>
          <p:cNvSpPr txBox="1"/>
          <p:nvPr/>
        </p:nvSpPr>
        <p:spPr>
          <a:xfrm>
            <a:off x="206848" y="-21632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6497210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FACE523-410E-1C95-E2D2-EAC1A569E597}"/>
              </a:ext>
            </a:extLst>
          </p:cNvPr>
          <p:cNvSpPr txBox="1"/>
          <p:nvPr/>
        </p:nvSpPr>
        <p:spPr>
          <a:xfrm>
            <a:off x="623347" y="423938"/>
            <a:ext cx="55945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2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Figure 2: Single cell-RNA sequencing in children with PANS before and after IVIg treatment: Dot plot of significant GO pathways across cell types </a:t>
            </a:r>
          </a:p>
          <a:p>
            <a:endParaRPr lang="en-SG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r>
              <a:rPr lang="en-SG" sz="1200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Bar plot of top 5 upregulated (in red) and downregulation (in blue) GSEA GO pathways</a:t>
            </a:r>
            <a:endParaRPr lang="en-SG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4223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6</TotalTime>
  <Words>83</Words>
  <Application>Microsoft Macintosh PowerPoint</Application>
  <PresentationFormat>A4 Paper (210x297 mm)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lda Han</dc:creator>
  <cp:lastModifiedBy>Velda Han</cp:lastModifiedBy>
  <cp:revision>26</cp:revision>
  <dcterms:created xsi:type="dcterms:W3CDTF">2025-02-27T06:52:39Z</dcterms:created>
  <dcterms:modified xsi:type="dcterms:W3CDTF">2025-03-10T05:25:36Z</dcterms:modified>
</cp:coreProperties>
</file>